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858000" cy="9144000"/>
          </a:xfrm>
          <a:custGeom>
            <a:avLst/>
            <a:gdLst>
              <a:gd name="textAreaLeft" fmla="*/ 360 w 6858000"/>
              <a:gd name="textAreaRight" fmla="*/ 6857640 w 6858000"/>
              <a:gd name="textAreaTop" fmla="*/ 360 h 9144000"/>
              <a:gd name="textAreaBottom" fmla="*/ 9143640 h 9144000"/>
            </a:gdLst>
            <a:ahLst/>
            <a:rect l="textAreaLeft" t="textAreaTop" r="textAreaRight" b="textAreaBottom"/>
            <a:pathLst>
              <a:path w="21600" h="28800">
                <a:moveTo>
                  <a:pt x="5" y="0"/>
                </a:moveTo>
                <a:arcTo wR="5" hR="5" stAng="16200000" swAng="-5400000"/>
                <a:lnTo>
                  <a:pt x="0" y="28795"/>
                </a:lnTo>
                <a:arcTo wR="5" hR="5" stAng="10800000" swAng="-5400000"/>
                <a:lnTo>
                  <a:pt x="21595" y="28800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1"/>
          <p:cNvSpPr>
            <a:spLocks noGrp="1"/>
          </p:cNvSpPr>
          <p:nvPr>
            <p:ph type="dt" idx="3"/>
          </p:nvPr>
        </p:nvSpPr>
        <p:spPr>
          <a:xfrm>
            <a:off x="3884760" y="0"/>
            <a:ext cx="2970000" cy="45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0560" cy="3427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4960" cy="411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PlaceHolder 4"/>
          <p:cNvSpPr>
            <a:spLocks noGrp="1"/>
          </p:cNvSpPr>
          <p:nvPr>
            <p:ph type="sldNum" idx="4"/>
          </p:nvPr>
        </p:nvSpPr>
        <p:spPr>
          <a:xfrm>
            <a:off x="3884760" y="8685000"/>
            <a:ext cx="2970000" cy="45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17C12910-69E6-47C7-A313-B34E8879E536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  <a:ea typeface="Arial Unicode MS"/>
            </a:endParaRPr>
          </a:p>
        </p:txBody>
      </p:sp>
      <p:sp>
        <p:nvSpPr>
          <p:cNvPr id="68" name="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4B2854E7-543A-436E-B090-385722409597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66A730-0C35-4E7B-9C10-0DCD952057DF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995B5F7-EDD3-4305-9ED8-3B578E19AD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FB41C8A-2AA3-4765-84D3-1CB8A91176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28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1360" y="16002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28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1360" y="3963600"/>
            <a:ext cx="264924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4C45DA2-A395-4C6B-9E15-5FFFF112CD8F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2F942F1-B23E-45DA-8973-6A16BC18E9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81143F5-CA3E-47AA-BA61-12D6B7AF7D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5B62C6A-1775-4ADB-8D14-A629990B39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D6BC26C-B180-4FAF-A488-7A8E5E03A1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128520"/>
            <a:ext cx="8228160" cy="6646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7CAFD6D-4614-43C6-9C17-2AD5A8558D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0D75241-E546-4D57-9866-EC6F66EBF6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3520" y="39636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4A91093-DD25-44CA-B4F5-B72B487A34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3520" y="1600200"/>
            <a:ext cx="401508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3600"/>
            <a:ext cx="822816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7286B42-1359-456D-828B-2A948DE78B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128520"/>
            <a:ext cx="8228160" cy="143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816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7200" y="6354360"/>
            <a:ext cx="213192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it-IT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35472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552720" y="6354360"/>
            <a:ext cx="213228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  <a:defRPr b="0" lang="it-IT" sz="18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fld id="{155919D2-B5C5-4714-9F9C-63F2D50B964C}" type="slidenum">
              <a:rPr b="0" lang="it-IT" sz="18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8184240" y="11592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"/>
          <p:cNvSpPr/>
          <p:nvPr/>
        </p:nvSpPr>
        <p:spPr>
          <a:xfrm>
            <a:off x="438120" y="4653000"/>
            <a:ext cx="82663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333080"/>
                <a:tab algn="l" pos="1078236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Figure S1.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Representative example of SDS-PAGE fractionation (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4-12% Bis-Tris Midi gradient gel)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and immunoblot analysis (primary antibody: 6E10 mAb, 1:500; secondary antibody: goat anti-mouse,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rDye 680-labeled antibody, 1:3000) carried out on 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“low-detergent”, 0.01% NP40/0.1% SDS brain extracts (enriched in extracellular A</a:t>
            </a:r>
            <a:r>
              <a:rPr b="0" lang="it-IT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). 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Immune-reactive bands were visualized by near-infrared fluorescence (Odyssey imager, LI-COR). Non-specific, 6E10 mAb cross-reactive polypeptides (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arrow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), present in both wild-type and Tg2576 brain extracts, were used as loading controls and internal references for data normalization. Synthetic prefibrillar A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42(n) prepared according to Lambert et al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[32]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, with </a:t>
            </a:r>
            <a:r>
              <a:rPr b="0" i="1" lang="en-GB" sz="1200" spc="-1" strike="noStrike">
                <a:solidFill>
                  <a:srgbClr val="000000"/>
                </a:solidFill>
                <a:latin typeface="Calibri"/>
              </a:rPr>
              <a:t>n</a:t>
            </a: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-values ranging from 1 to 4 (not shown), was used as size standard for electrophoretic analysis. Immune-reactive bands were quantified as “near-infrared fluorescence” (NIRF) arbitrary units (see ‘Materials and Methods’ for additional details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1" name=""/>
          <p:cNvCxnSpPr/>
          <p:nvPr/>
        </p:nvCxnSpPr>
        <p:spPr>
          <a:xfrm flipH="1">
            <a:off x="5500440" y="3333240"/>
            <a:ext cx="210240" cy="25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triangle" w="med"/>
          </a:ln>
        </p:spPr>
      </p:cxnSp>
      <p:grpSp>
        <p:nvGrpSpPr>
          <p:cNvPr id="52" name=""/>
          <p:cNvGrpSpPr/>
          <p:nvPr/>
        </p:nvGrpSpPr>
        <p:grpSpPr>
          <a:xfrm>
            <a:off x="3086640" y="1370160"/>
            <a:ext cx="2933280" cy="3005640"/>
            <a:chOff x="3086640" y="1370160"/>
            <a:chExt cx="2933280" cy="3005640"/>
          </a:xfrm>
        </p:grpSpPr>
        <p:sp>
          <p:nvSpPr>
            <p:cNvPr id="53" name=""/>
            <p:cNvSpPr/>
            <p:nvPr/>
          </p:nvSpPr>
          <p:spPr>
            <a:xfrm>
              <a:off x="5493960" y="4225680"/>
              <a:ext cx="968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493960" y="3892320"/>
              <a:ext cx="968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93960" y="3814560"/>
              <a:ext cx="968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494680" y="4114440"/>
              <a:ext cx="525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Calibri"/>
                </a:rPr>
                <a:t>1-me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494680" y="3776400"/>
              <a:ext cx="525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Calibri"/>
                </a:rPr>
                <a:t>2-me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494680" y="3687840"/>
              <a:ext cx="525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100" spc="-1" strike="noStrike">
                  <a:solidFill>
                    <a:srgbClr val="000000"/>
                  </a:solidFill>
                  <a:latin typeface="Calibri"/>
                </a:rPr>
                <a:t>3-mer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086640" y="1370160"/>
              <a:ext cx="6865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Wild-typ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control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300480" y="1726920"/>
              <a:ext cx="27144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435200" y="1379160"/>
              <a:ext cx="11257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Tg2576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CHF5074 375 pp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777840" y="1379160"/>
              <a:ext cx="586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Tg2576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  <a:tab algn="l" pos="10333080"/>
                  <a:tab algn="l" pos="1078236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Calibri"/>
                </a:rPr>
                <a:t>vehicl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14760" y="1723680"/>
              <a:ext cx="87192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571280" y="1723680"/>
              <a:ext cx="871920" cy="0"/>
            </a:xfrm>
            <a:prstGeom prst="line">
              <a:avLst/>
            </a:prstGeom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5" name="" descr=""/>
            <p:cNvPicPr/>
            <p:nvPr/>
          </p:nvPicPr>
          <p:blipFill>
            <a:blip r:embed="rId1"/>
            <a:stretch/>
          </p:blipFill>
          <p:spPr>
            <a:xfrm>
              <a:off x="3303720" y="1771200"/>
              <a:ext cx="2159640" cy="2590560"/>
            </a:xfrm>
            <a:prstGeom prst="rect">
              <a:avLst/>
            </a:prstGeom>
            <a:ln w="0">
              <a:noFill/>
            </a:ln>
          </p:spPr>
        </p:pic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5T12:23:49Z</dcterms:created>
  <dc:creator>roberto</dc:creator>
  <dc:description/>
  <dc:language>en-US</dc:language>
  <cp:lastModifiedBy>Simone Ottonello</cp:lastModifiedBy>
  <dcterms:modified xsi:type="dcterms:W3CDTF">2013-01-11T15:55:22Z</dcterms:modified>
  <cp:revision>11</cp:revision>
  <dc:subject/>
  <dc:title>Presentazione standard di PowerPoint</dc:title>
</cp:coreProperties>
</file>